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142" autoAdjust="0"/>
  </p:normalViewPr>
  <p:slideViewPr>
    <p:cSldViewPr snapToGrid="0">
      <p:cViewPr>
        <p:scale>
          <a:sx n="100" d="100"/>
          <a:sy n="100" d="100"/>
        </p:scale>
        <p:origin x="-1848" y="-72"/>
      </p:cViewPr>
      <p:guideLst>
        <p:guide orient="horz" pos="2880"/>
        <p:guide pos="3132"/>
      </p:guideLst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86B55A-1642-41A0-9291-C5CFD1A80D6A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DEB582-E75E-4700-9E01-481FCB63F0F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92238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49153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34608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67380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77475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84755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0261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44883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69213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31348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7958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09958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93072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1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1972" y="4118065"/>
            <a:ext cx="2733853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" name="Picture 1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779" y="4115863"/>
            <a:ext cx="2737510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9" name="Picture 1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1973" y="2455766"/>
            <a:ext cx="2743910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2" name="Picture 1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579" y="2455766"/>
            <a:ext cx="2743910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274485" y="57334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84563" y="573349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56794" y="508901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797154" y="508901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429"/>
          <p:cNvSpPr txBox="1"/>
          <p:nvPr/>
        </p:nvSpPr>
        <p:spPr>
          <a:xfrm rot="16200000">
            <a:off x="-140384" y="3165085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ilirubin (µ</a:t>
            </a:r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429"/>
          <p:cNvSpPr txBox="1"/>
          <p:nvPr/>
        </p:nvSpPr>
        <p:spPr>
          <a:xfrm rot="16200000">
            <a:off x="3037282" y="3103529"/>
            <a:ext cx="12869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Bilirubin (µ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  <a:p>
            <a:pPr algn="ctr"/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60648" y="227653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470726" y="227653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429"/>
          <p:cNvSpPr txBox="1"/>
          <p:nvPr/>
        </p:nvSpPr>
        <p:spPr>
          <a:xfrm rot="16200000">
            <a:off x="-131070" y="4840659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dium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mmol/L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429"/>
          <p:cNvSpPr txBox="1"/>
          <p:nvPr/>
        </p:nvSpPr>
        <p:spPr>
          <a:xfrm rot="16200000">
            <a:off x="3046594" y="4840659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dium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mmol/L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228271" y="271464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404548" y="292032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601"/>
          <p:cNvSpPr txBox="1"/>
          <p:nvPr/>
        </p:nvSpPr>
        <p:spPr>
          <a:xfrm>
            <a:off x="919864" y="5771333"/>
            <a:ext cx="19831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ys post 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de-CH" sz="800" i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emofelis 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601"/>
          <p:cNvSpPr txBox="1"/>
          <p:nvPr/>
        </p:nvSpPr>
        <p:spPr>
          <a:xfrm>
            <a:off x="4076768" y="5771333"/>
            <a:ext cx="20763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ys post 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de-CH" sz="800" i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emofelis 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233660" y="457378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664717" y="457361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499860" y="457121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989741" y="449860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642056" y="449860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>
            <a:off x="836712" y="271464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4026699" y="271464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882205" y="515899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882205" y="420649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4026699" y="515899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4026699" y="420649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Picture 1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1282" y="793682"/>
            <a:ext cx="2742996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0" name="TextBox 429"/>
          <p:cNvSpPr txBox="1"/>
          <p:nvPr/>
        </p:nvSpPr>
        <p:spPr>
          <a:xfrm rot="16200000">
            <a:off x="-208785" y="1409648"/>
            <a:ext cx="15861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kaline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Phosphatase (U/L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429"/>
          <p:cNvSpPr txBox="1"/>
          <p:nvPr/>
        </p:nvSpPr>
        <p:spPr>
          <a:xfrm rot="16200000">
            <a:off x="2984121" y="1436439"/>
            <a:ext cx="14529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kaline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Phosphatase 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(U/L)</a:t>
            </a:r>
          </a:p>
        </p:txBody>
      </p:sp>
      <p:pic>
        <p:nvPicPr>
          <p:cNvPr id="52" name="Picture 1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1743" y="793682"/>
            <a:ext cx="2742996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3" name="Straight Connector 52"/>
          <p:cNvCxnSpPr/>
          <p:nvPr/>
        </p:nvCxnSpPr>
        <p:spPr>
          <a:xfrm>
            <a:off x="1158502" y="1477855"/>
            <a:ext cx="284996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1190011" y="1305263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>
            <a:off x="858847" y="1617070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855672" y="842370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4031370" y="161914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4028195" y="84444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269212" y="4083049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479289" y="4083049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586723" y="271464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904420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</dc:creator>
  <cp:lastModifiedBy>Regina Hofmann</cp:lastModifiedBy>
  <cp:revision>216</cp:revision>
  <cp:lastPrinted>2015-04-09T09:13:44Z</cp:lastPrinted>
  <dcterms:created xsi:type="dcterms:W3CDTF">2013-01-23T18:37:05Z</dcterms:created>
  <dcterms:modified xsi:type="dcterms:W3CDTF">2015-07-29T11:49:24Z</dcterms:modified>
</cp:coreProperties>
</file>